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74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68F633-443E-4954-BDDC-5E626EADC9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1442373-3A0C-3F3E-F0CD-CC113C0390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B09C66-A567-411C-A25B-6A8AE26D01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7C99E-40C9-47C0-8DD3-A486B9561B12}" type="datetimeFigureOut">
              <a:rPr lang="it-IT" smtClean="0"/>
              <a:t>17/03/2023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1DA396-0946-9364-0CB8-5BF5166162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E24B46-24B3-504F-379A-57626B4862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0DF19-C283-4C5C-85A0-3B65373C80D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60162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EFCA25-F000-688D-FFDD-D752D6BAD0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DC402B-B9CF-800F-1975-4E4B06ECFB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8C9A26-31F9-EE29-E932-FA3828598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7C99E-40C9-47C0-8DD3-A486B9561B12}" type="datetimeFigureOut">
              <a:rPr lang="it-IT" smtClean="0"/>
              <a:t>17/03/2023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9E3BC1-2122-15DF-2283-B869EDEAD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18B0F7-C51B-CE51-6CC8-999B1E993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0DF19-C283-4C5C-85A0-3B65373C80D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6186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D24751-CD7A-ABDA-0FB3-337FCA800D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138DD1-F574-DB28-5757-C25EE26917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C5D99D-9529-6973-CD8C-325F5B0AD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7C99E-40C9-47C0-8DD3-A486B9561B12}" type="datetimeFigureOut">
              <a:rPr lang="it-IT" smtClean="0"/>
              <a:t>17/03/2023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3EE9D8-BF98-DAE3-89ED-4461C67E4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2CE8D6-3584-D42B-4205-6A2468CEC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0DF19-C283-4C5C-85A0-3B65373C80D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6759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3CA791-F47C-988A-AC5F-A9B3AFA7F2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248653-FC57-7EAE-9402-1D9654680D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16A80E-3974-3BBC-7AA1-EE7E36427A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7C99E-40C9-47C0-8DD3-A486B9561B12}" type="datetimeFigureOut">
              <a:rPr lang="it-IT" smtClean="0"/>
              <a:t>17/03/2023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5D75E6-1ACA-C2EF-0B5C-13E77B89C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8F19A8-77B7-EBBD-9795-1F79E0A5C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0DF19-C283-4C5C-85A0-3B65373C80D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62272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32D18E-0788-E438-467A-EBEB6FD9F2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B71AA1-6D98-8401-C65B-FE4657099B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D12C4D-866F-8BC3-8898-A31BA65A7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7C99E-40C9-47C0-8DD3-A486B9561B12}" type="datetimeFigureOut">
              <a:rPr lang="it-IT" smtClean="0"/>
              <a:t>17/03/2023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470406-E361-2163-AC44-2BB69DE85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FA0E9C-EBC6-BD4D-57B0-6A7DB8304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0DF19-C283-4C5C-85A0-3B65373C80D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93799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9A90F0-8D98-FE6E-B609-D1C328F893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4C7F7C-F47C-CCC6-D55D-7D978727D3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0882D0-951E-740F-AFDA-8DA9AE5CA5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9FD95D-002B-E6E7-C87A-E25F2C1230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7C99E-40C9-47C0-8DD3-A486B9561B12}" type="datetimeFigureOut">
              <a:rPr lang="it-IT" smtClean="0"/>
              <a:t>17/03/2023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AC17C8-8B7C-FD49-E33D-B1DCEFFD9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225004-5DD5-12AB-CA69-B4E3A075E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0DF19-C283-4C5C-85A0-3B65373C80D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650495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F8535E-B217-8189-5388-C4E2811805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FCEB71-4ACF-4996-C1A2-1D47ABC88E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F5916DB-32DE-5732-9D1C-0337CE6E54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D48DD8-1915-13D2-CA4E-6327468005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DB43DB-2B1E-30EA-0460-479516ACAE7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ACFE5D-7F48-B078-074F-FADFC93129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7C99E-40C9-47C0-8DD3-A486B9561B12}" type="datetimeFigureOut">
              <a:rPr lang="it-IT" smtClean="0"/>
              <a:t>17/03/2023</a:t>
            </a:fld>
            <a:endParaRPr lang="it-I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1E742EE-0808-752A-A413-328FDEFFA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AE112F-61E2-4346-7733-1AD39ABC38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0DF19-C283-4C5C-85A0-3B65373C80D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3880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7E16E3-C212-4A97-FC2A-40D7827785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E9EB6E-3250-04C8-8FBF-0414B78A43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7C99E-40C9-47C0-8DD3-A486B9561B12}" type="datetimeFigureOut">
              <a:rPr lang="it-IT" smtClean="0"/>
              <a:t>17/03/2023</a:t>
            </a:fld>
            <a:endParaRPr lang="it-I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7C33B79-4983-CA94-2DF7-B04FE45B5D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5DF8D0D-0A87-FF60-93C4-07DF907F2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0DF19-C283-4C5C-85A0-3B65373C80D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7182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BB55475-E2F6-6B28-8D7C-25524ED428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7C99E-40C9-47C0-8DD3-A486B9561B12}" type="datetimeFigureOut">
              <a:rPr lang="it-IT" smtClean="0"/>
              <a:t>17/03/2023</a:t>
            </a:fld>
            <a:endParaRPr lang="it-I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69B5CDD-2808-4728-2673-0579ABCD7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29DC4F6-A7C9-2C96-3554-57F86EC38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0DF19-C283-4C5C-85A0-3B65373C80D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8870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FBB9AA-37B2-F904-8C12-59293FEF3E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976143-7F7B-CE5D-FBA2-99B17B81F6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52A148-5DBD-854A-A86C-AD74AEF7F2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2A2B28-C3F0-E0E9-9799-C9931CF7FA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7C99E-40C9-47C0-8DD3-A486B9561B12}" type="datetimeFigureOut">
              <a:rPr lang="it-IT" smtClean="0"/>
              <a:t>17/03/2023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A3EFE6-354C-831F-D0E2-F9B84D724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E40915-03A2-416C-FE6F-F160D2FC0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0DF19-C283-4C5C-85A0-3B65373C80D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9672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257DED-F406-5714-59E1-5F6FD2318A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024CA5-EFA6-6513-6833-077ABE9847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EE240C-8D31-09A8-57E4-3084F28338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F32174-8E5B-DA0A-9277-04B972DC9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7C99E-40C9-47C0-8DD3-A486B9561B12}" type="datetimeFigureOut">
              <a:rPr lang="it-IT" smtClean="0"/>
              <a:t>17/03/2023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2B6F4C-6590-A96F-0A8A-76DF3D5B8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63E735-6C4D-E9EE-B616-F74E6F764E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0DF19-C283-4C5C-85A0-3B65373C80D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2007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856C0CA-92A5-CB2B-40A3-AD753AA363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86E0D4-D2BC-3A94-0D0B-66E5964824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E1DBF3-98F9-ED84-74F1-6C6ED61D691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7C99E-40C9-47C0-8DD3-A486B9561B12}" type="datetimeFigureOut">
              <a:rPr lang="it-IT" smtClean="0"/>
              <a:t>17/03/2023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69FCB1-39FD-F320-3C24-C35A8C934F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02A75E-BEA1-3447-FB27-7396761609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D0DF19-C283-4C5C-85A0-3B65373C80D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85526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Supplementary Video X time lapse data analysis example">
            <a:hlinkClick r:id="" action="ppaction://media"/>
            <a:extLst>
              <a:ext uri="{FF2B5EF4-FFF2-40B4-BE49-F238E27FC236}">
                <a16:creationId xmlns:a16="http://schemas.microsoft.com/office/drawing/2014/main" id="{D17AACE9-DE70-02F2-38A5-FEDC6A4099BA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667000" y="0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89410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2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E41BAB-3726-DA02-6EFA-F310BF944738}"/>
              </a:ext>
            </a:extLst>
          </p:cNvPr>
          <p:cNvSpPr txBox="1"/>
          <p:nvPr/>
        </p:nvSpPr>
        <p:spPr>
          <a:xfrm>
            <a:off x="517236" y="498764"/>
            <a:ext cx="1149927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Video S1.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ample timelapse video of Brightfield (top left) and dox channels (top right) of sample “CEM/ADR5000 cells + 20 µM doxorubicin + 4 x IC</a:t>
            </a:r>
            <a:r>
              <a:rPr lang="en-US" sz="1800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mpound 5” with corresponding segmented frames below. All cells segmented from Brightfield images and CEM/ADR5000 cells + 20 µM doxorubicin + 4 x IC</a:t>
            </a:r>
            <a:r>
              <a:rPr lang="en-US" sz="1800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mpound 5 segmented from dox channel. (Timestamp unit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ours:minutes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710892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7</Words>
  <Application>Microsoft Office PowerPoint</Application>
  <PresentationFormat>Widescreen</PresentationFormat>
  <Paragraphs>1</Paragraphs>
  <Slides>2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eo Rosellini</dc:creator>
  <cp:lastModifiedBy>MDPI</cp:lastModifiedBy>
  <cp:revision>6</cp:revision>
  <dcterms:created xsi:type="dcterms:W3CDTF">2022-12-01T16:14:19Z</dcterms:created>
  <dcterms:modified xsi:type="dcterms:W3CDTF">2023-03-17T03:53:53Z</dcterms:modified>
</cp:coreProperties>
</file>